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media/image3.png" ContentType="image/png"/>
  <Override PartName="/ppt/media/image4.png" ContentType="image/png"/>
  <Override PartName="/ppt/media/image5.png" ContentType="image/png"/>
  <Override PartName="/ppt/embeddings/oleObject1.docx" ContentType="application/vnd.openxmlformats-officedocument.wordprocessingml.documen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315200" cy="10058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F9A49F-202A-48DF-825B-459D96DED66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65040" y="2346120"/>
            <a:ext cx="658512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65040" y="5814000"/>
            <a:ext cx="658512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D7B64C-86B8-4717-8844-F9718C29E9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65040" y="234612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739320" y="234612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65040" y="581400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739320" y="581400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4729BC-226B-40DC-A977-CFBB2D34EC3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65040" y="2346120"/>
            <a:ext cx="212004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91640" y="2346120"/>
            <a:ext cx="212004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817880" y="2346120"/>
            <a:ext cx="212004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65040" y="5814000"/>
            <a:ext cx="212004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91640" y="5814000"/>
            <a:ext cx="212004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817880" y="5814000"/>
            <a:ext cx="212004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329A3F-1F4D-4EDD-B060-3B3493C42B8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65040" y="2346120"/>
            <a:ext cx="6585120" cy="6638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28EF44-136A-4C72-97F5-DA32D16658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65040" y="2346120"/>
            <a:ext cx="658512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A401E0-CD12-4B07-A2EF-191E45E545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65040" y="2346120"/>
            <a:ext cx="321336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739320" y="2346120"/>
            <a:ext cx="321336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480E25-1F4D-4211-B508-567AB0EEFD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C3D1DF-7D82-4EC5-ACEB-90CAD9B379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65040" y="402840"/>
            <a:ext cx="6585120" cy="7772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847195-4112-4544-B9FD-4533004503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65040" y="234612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739320" y="2346120"/>
            <a:ext cx="321336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65040" y="581400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FCF390-C045-44F1-AC3E-D089560771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65040" y="2346120"/>
            <a:ext cx="321336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739320" y="234612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739320" y="581400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60756F-FC8A-4502-8996-65629B30E5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65040" y="234612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739320" y="2346120"/>
            <a:ext cx="32133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65040" y="5814000"/>
            <a:ext cx="658512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AD3B21-AE72-4EFB-B192-A973803138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5040" y="402840"/>
            <a:ext cx="658512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5040" y="2346120"/>
            <a:ext cx="658512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4680" y="9159840"/>
            <a:ext cx="1708200" cy="698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98760" y="9159840"/>
            <a:ext cx="2317680" cy="698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241600" y="9159840"/>
            <a:ext cx="1708200" cy="698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A1F5807-27B5-492B-8B65-FE8A6B14CCF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package" Target="../embeddings/oleObject1.docx"/><Relationship Id="rId3" Type="http://schemas.openxmlformats.org/officeDocument/2006/relationships/image" Target="../media/image2.wmf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51" descr=""/>
          <p:cNvPicPr/>
          <p:nvPr/>
        </p:nvPicPr>
        <p:blipFill>
          <a:blip r:embed="rId1"/>
          <a:stretch/>
        </p:blipFill>
        <p:spPr>
          <a:xfrm>
            <a:off x="990720" y="3178080"/>
            <a:ext cx="6324480" cy="712800"/>
          </a:xfrm>
          <a:prstGeom prst="rect">
            <a:avLst/>
          </a:prstGeom>
          <a:ln w="0">
            <a:noFill/>
          </a:ln>
        </p:spPr>
      </p:pic>
      <p:sp>
        <p:nvSpPr>
          <p:cNvPr id="42" name="Text Box 9"/>
          <p:cNvSpPr/>
          <p:nvPr/>
        </p:nvSpPr>
        <p:spPr>
          <a:xfrm>
            <a:off x="152280" y="152280"/>
            <a:ext cx="3505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Additional File 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9"/>
          <p:cNvSpPr/>
          <p:nvPr/>
        </p:nvSpPr>
        <p:spPr>
          <a:xfrm>
            <a:off x="0" y="876600"/>
            <a:ext cx="914400" cy="799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52280" bIns="3816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  <a:ea typeface="SimSun"/>
              </a:rPr>
              <a:t>A: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Z. mobili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ZMO034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20"/>
          <p:cNvSpPr/>
          <p:nvPr/>
        </p:nvSpPr>
        <p:spPr>
          <a:xfrm>
            <a:off x="0" y="1837080"/>
            <a:ext cx="914400" cy="98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52280" bIns="3816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  <a:ea typeface="SimSun"/>
              </a:rPr>
              <a:t>B: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E. coli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Hfq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b417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5" name="Object 44"/>
          <p:cNvGraphicFramePr/>
          <p:nvPr/>
        </p:nvGraphicFramePr>
        <p:xfrm>
          <a:off x="314280" y="5486400"/>
          <a:ext cx="7153200" cy="4343400"/>
        </p:xfrm>
        <a:graphic>
          <a:graphicData uri="http://schemas.openxmlformats.org/presentationml/2006/ole">
            <p:oleObj progId="Word.Document.12" r:id="rId2" spid="">
              <p:embed/>
              <p:pic>
                <p:nvPicPr>
                  <p:cNvPr id="46" name="Object 44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314280" y="5486400"/>
                    <a:ext cx="7153200" cy="4343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7" name="Rectangle 45"/>
          <p:cNvSpPr/>
          <p:nvPr/>
        </p:nvSpPr>
        <p:spPr>
          <a:xfrm>
            <a:off x="85680" y="5304240"/>
            <a:ext cx="685800" cy="67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52280" bIns="3816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  <a:ea typeface="SimSun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46"/>
          <p:cNvSpPr/>
          <p:nvPr/>
        </p:nvSpPr>
        <p:spPr>
          <a:xfrm>
            <a:off x="0" y="2873880"/>
            <a:ext cx="1066680" cy="116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52280" bIns="3816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  <a:ea typeface="SimSun"/>
              </a:rPr>
              <a:t>C: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S. cerevisiae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Sm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(YER029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47"/>
          <p:cNvSpPr/>
          <p:nvPr/>
        </p:nvSpPr>
        <p:spPr>
          <a:xfrm>
            <a:off x="0" y="4016880"/>
            <a:ext cx="1066680" cy="116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152280" bIns="3816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  <a:ea typeface="SimSun"/>
              </a:rPr>
              <a:t>D: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S. cerevisiae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Lsm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(YJL124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49" descr=""/>
          <p:cNvPicPr/>
          <p:nvPr/>
        </p:nvPicPr>
        <p:blipFill>
          <a:blip r:embed="rId4"/>
          <a:stretch/>
        </p:blipFill>
        <p:spPr>
          <a:xfrm>
            <a:off x="914400" y="838080"/>
            <a:ext cx="6400800" cy="79848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50" descr=""/>
          <p:cNvPicPr/>
          <p:nvPr/>
        </p:nvPicPr>
        <p:blipFill>
          <a:blip r:embed="rId5"/>
          <a:stretch/>
        </p:blipFill>
        <p:spPr>
          <a:xfrm>
            <a:off x="1219320" y="1974960"/>
            <a:ext cx="4038480" cy="80640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52" descr=""/>
          <p:cNvPicPr/>
          <p:nvPr/>
        </p:nvPicPr>
        <p:blipFill>
          <a:blip r:embed="rId6"/>
          <a:stretch/>
        </p:blipFill>
        <p:spPr>
          <a:xfrm>
            <a:off x="1066680" y="4405320"/>
            <a:ext cx="5639040" cy="642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27T15:10:19Z</dcterms:created>
  <dc:creator>SHIHUI YANG</dc:creator>
  <dc:description/>
  <dc:language>en-US</dc:language>
  <cp:lastModifiedBy>s95</cp:lastModifiedBy>
  <dcterms:modified xsi:type="dcterms:W3CDTF">2010-02-03T16:36:33Z</dcterms:modified>
  <cp:revision>9</cp:revision>
  <dc:subject/>
  <dc:title>Slide 1</dc:title>
</cp:coreProperties>
</file>